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  <p:sldId id="259" r:id="rId5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9" autoAdjust="0"/>
    <p:restoredTop sz="94660"/>
  </p:normalViewPr>
  <p:slideViewPr>
    <p:cSldViewPr snapToGrid="0">
      <p:cViewPr>
        <p:scale>
          <a:sx n="143" d="100"/>
          <a:sy n="143" d="100"/>
        </p:scale>
        <p:origin x="70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10806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3875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8082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1025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7426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9733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5714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8904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6949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4453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4078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58BCE-1058-4114-83E4-CF225E2D8990}" type="datetimeFigureOut">
              <a:rPr lang="es-ES" smtClean="0"/>
              <a:t>10/8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F29566-47E6-412E-AC7D-5CF851FC1C7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4883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16">
            <a:extLst>
              <a:ext uri="{FF2B5EF4-FFF2-40B4-BE49-F238E27FC236}">
                <a16:creationId xmlns:a16="http://schemas.microsoft.com/office/drawing/2014/main" id="{2D4EB13E-AE59-4113-BDA9-D98E1A4724CA}"/>
              </a:ext>
            </a:extLst>
          </p:cNvPr>
          <p:cNvSpPr txBox="1"/>
          <p:nvPr/>
        </p:nvSpPr>
        <p:spPr>
          <a:xfrm>
            <a:off x="503237" y="639256"/>
            <a:ext cx="6553200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-index and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-index) plots on the 11 chromosomes of watermelon.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-index plots of SNPs in the M-bulk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he PA-bulk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plots of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-index) of the two bulk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rom QTL-seq analysis. X-axis represents the position of the eleven chromosomes and Y-axis represents the SNP-index.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ack lines indicate the sliding window average of 1Mb interval with 10 kb increment for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-index).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 allele frequency was defined in 0.3 (0.3 ≤ reference allele frequency ≤ 0.7), minimum total sample read depth ≥20, maximum total sample read depth ≤100, minimum per sample read depth ≥10, minimum genotype quality ≥ 99. A candidate QTL (QTL1) location was identified on watermelon chromosome 1 (32.2 - 36.4 Mb interval) with the criteria that the SNP-index in M-bulk (A) was near 1, SNP-index in PA-bulk (B) was near 0 and the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-index) (C) was above the confidence value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12378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8EFA2C79-26B1-4525-8FF1-90EE8125868E}"/>
              </a:ext>
            </a:extLst>
          </p:cNvPr>
          <p:cNvSpPr/>
          <p:nvPr/>
        </p:nvSpPr>
        <p:spPr>
          <a:xfrm>
            <a:off x="160450" y="201977"/>
            <a:ext cx="723877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NP-index plot of SNPs in the bulked DNA from F2 plants showing the monoecious phenotype (M-bulk) derived from a cross between P84 and P86.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714870BA-2BB5-4DD3-A7F7-7F25A95AD8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752" y="810826"/>
            <a:ext cx="6338167" cy="9495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79128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CF2F98E1-97E9-4848-98AD-8E751E86E4FD}"/>
              </a:ext>
            </a:extLst>
          </p:cNvPr>
          <p:cNvSpPr/>
          <p:nvPr/>
        </p:nvSpPr>
        <p:spPr>
          <a:xfrm>
            <a:off x="130627" y="129406"/>
            <a:ext cx="721360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NP-index plot of SNPs in the bulked DNA of F2 showing the partially andromonoecious phenotype (PA-bulk) derived from a cross between P84 and P86.</a:t>
            </a:r>
          </a:p>
        </p:txBody>
      </p:sp>
      <p:pic>
        <p:nvPicPr>
          <p:cNvPr id="18" name="Imagen 17">
            <a:extLst>
              <a:ext uri="{FF2B5EF4-FFF2-40B4-BE49-F238E27FC236}">
                <a16:creationId xmlns:a16="http://schemas.microsoft.com/office/drawing/2014/main" id="{F0544AA2-5014-4235-B8B7-64500BA722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212" y="722243"/>
            <a:ext cx="6359250" cy="92473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96703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BE563DCE-898F-408D-B964-4A2571D15F16}"/>
              </a:ext>
            </a:extLst>
          </p:cNvPr>
          <p:cNvSpPr/>
          <p:nvPr/>
        </p:nvSpPr>
        <p:spPr>
          <a:xfrm>
            <a:off x="163513" y="141466"/>
            <a:ext cx="72097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Δ (SNP-index) plot obtained by subtraction of M-bulk SNP-index from PA-bulk SNP-index. Statistical confidence intervals under the null hypothesis of no QTL are shown as pink (P &lt; 0.05) or green (P &lt; 0.01).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8E96C4ED-F21E-4D6A-A919-EA4A1FFC2D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661" y="997527"/>
            <a:ext cx="6165447" cy="9374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90450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7</TotalTime>
  <Words>295</Words>
  <Application>Microsoft Macintosh PowerPoint</Application>
  <PresentationFormat>Personalizado</PresentationFormat>
  <Paragraphs>7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ncarni</dc:creator>
  <cp:lastModifiedBy>Manuel Jamilena</cp:lastModifiedBy>
  <cp:revision>24</cp:revision>
  <dcterms:created xsi:type="dcterms:W3CDTF">2020-03-18T10:52:13Z</dcterms:created>
  <dcterms:modified xsi:type="dcterms:W3CDTF">2020-08-10T11:21:26Z</dcterms:modified>
</cp:coreProperties>
</file>